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svg" ContentType="image/svg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8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94C7C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10"/>
    <p:restoredTop sz="95755"/>
  </p:normalViewPr>
  <p:slideViewPr>
    <p:cSldViewPr snapToGrid="0" snapToObjects="1">
      <p:cViewPr varScale="1">
        <p:scale>
          <a:sx n="105" d="100"/>
          <a:sy n="105" d="100"/>
        </p:scale>
        <p:origin x="744" y="20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2137B92-D1B2-E54F-A39C-C808C741A4EC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DCE67147-52D3-534C-9728-6D09FC4011C1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9BAA4B7-C47D-764A-9709-BD009621752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55DD28-DE96-C24B-990D-383E662EF2E0}" type="datetimeFigureOut">
              <a:rPr lang="en-US" smtClean="0"/>
              <a:t>9/27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641EBB9-732B-6F40-B2E3-56FF2E6D540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3358FA5-1B88-924D-BDFB-57D014D32BA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147C02-A659-5E4A-90C1-E3CE6C1002A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817618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63F546E-FD60-BD46-959E-CBCBB8C2BAF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91673C26-B4A7-D749-B6D6-D8A1CF5746B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5F36917-904D-7546-BCAC-18F46BF8FEA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55DD28-DE96-C24B-990D-383E662EF2E0}" type="datetimeFigureOut">
              <a:rPr lang="en-US" smtClean="0"/>
              <a:t>9/27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36C88B8-D5A8-CB41-A1E1-86E2BE7DBE0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A3AE45E-C7AD-DB4D-8B01-5385D9C1D9E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147C02-A659-5E4A-90C1-E3CE6C1002A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1674495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7E8CFFDD-A6E3-9F4C-B425-FA82BFC31F56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09AD7719-DA60-7647-A971-7C78F0B45A4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F0FE9E8-4B85-FA4B-A2AF-7F2D4863E9A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55DD28-DE96-C24B-990D-383E662EF2E0}" type="datetimeFigureOut">
              <a:rPr lang="en-US" smtClean="0"/>
              <a:t>9/27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0C53187-64F4-F042-8FB1-DDA7C45CDF6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773C532-859D-5C45-98C5-6FE737880E8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147C02-A659-5E4A-90C1-E3CE6C1002A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5361918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07F7778-B702-994C-A20B-B6D2CC60757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4C29DBB-4666-CC42-B0FC-5577B598C6A3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A9202BE-4A1C-D84B-B583-84E4E676CDD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55DD28-DE96-C24B-990D-383E662EF2E0}" type="datetimeFigureOut">
              <a:rPr lang="en-US" smtClean="0"/>
              <a:t>9/27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247A403-AB70-384F-BE92-62A5D1370CC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F18CEF6-5A7E-844E-BC50-F2EA734B5DD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147C02-A659-5E4A-90C1-E3CE6C1002A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1407581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C2225C8-1A99-D147-BC45-51CD6A94529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530C899-A7FD-EA4E-9143-2285371DF1F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7ECFCEB-9610-2E48-B848-09A2802D8A0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55DD28-DE96-C24B-990D-383E662EF2E0}" type="datetimeFigureOut">
              <a:rPr lang="en-US" smtClean="0"/>
              <a:t>9/27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2C26180-F603-FC40-99D4-DBE50863DB9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210CC79-90C3-6342-92BA-6B1816D678C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147C02-A659-5E4A-90C1-E3CE6C1002A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0616476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E002C05-FBDD-D746-8DCB-957B575F131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B8525C4-39BF-994C-B7A0-4134CE45BB4D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D824224B-ADE0-354C-8A6C-07C6D02DC1E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161F424-0009-4742-82F0-8182E73D9E9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55DD28-DE96-C24B-990D-383E662EF2E0}" type="datetimeFigureOut">
              <a:rPr lang="en-US" smtClean="0"/>
              <a:t>9/27/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778FEA6-7FB7-D64A-B08A-45F0FBB0008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F3EE224-FD22-3740-92D7-2B4A1412D86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147C02-A659-5E4A-90C1-E3CE6C1002A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713803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D623453-3042-6248-A55F-33D4B319915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E9FE6A9-E2B3-4042-8BE0-F538F8CD56B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9734BEC7-7237-AD4C-ABDD-F5A785FF09C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4316DE98-594D-7C49-83DD-CE8FA5027D5B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804FED16-2719-B94C-9D28-79B848E1AE17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82C739D3-4F62-6D44-85E8-D39AC72B4B3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55DD28-DE96-C24B-990D-383E662EF2E0}" type="datetimeFigureOut">
              <a:rPr lang="en-US" smtClean="0"/>
              <a:t>9/27/21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D9C8DFD5-24FA-0F4D-97B9-50A0BEC576E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89E0FDC2-A4E3-F644-A742-14925A25DF1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147C02-A659-5E4A-90C1-E3CE6C1002A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543223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91F5E40-8E86-964F-9AF3-7FB4F82D99A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7770BACC-79E9-A045-A740-AC87D93F776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55DD28-DE96-C24B-990D-383E662EF2E0}" type="datetimeFigureOut">
              <a:rPr lang="en-US" smtClean="0"/>
              <a:t>9/27/21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E689534F-6E3B-D444-A12B-5C4666C397B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6D5ED838-01F2-6548-83B0-6DF8530FC49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147C02-A659-5E4A-90C1-E3CE6C1002A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5418441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684335C4-D14B-CB40-A243-6BEC7BD5C3E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55DD28-DE96-C24B-990D-383E662EF2E0}" type="datetimeFigureOut">
              <a:rPr lang="en-US" smtClean="0"/>
              <a:t>9/27/21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827FB0AF-C783-B34D-8032-290CDF52C37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97CF5C3C-36FC-8549-812F-F808747CF43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147C02-A659-5E4A-90C1-E3CE6C1002A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4051646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F129856-A1CA-5E42-87FC-E1011581F1A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DCC48B7-9768-7342-AEDD-33204EC1BD9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2F7605E1-6859-C14B-851F-929872F1E53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0C594B4-ACB4-9442-90DE-69E3C320036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55DD28-DE96-C24B-990D-383E662EF2E0}" type="datetimeFigureOut">
              <a:rPr lang="en-US" smtClean="0"/>
              <a:t>9/27/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64E6424-4EED-834F-BB3A-A86D372E650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A1773A6-D22A-BB42-835D-49077A25066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147C02-A659-5E4A-90C1-E3CE6C1002A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0317090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9B08EB6-A3BE-D144-8531-2F07BDAF3F3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A476EA59-4F2C-F747-96A8-FAA85196C04B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C2C3F72-4362-4F41-8AB3-7A3637BD0AF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C1EC075-0475-B945-A075-B7856ACDF70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55DD28-DE96-C24B-990D-383E662EF2E0}" type="datetimeFigureOut">
              <a:rPr lang="en-US" smtClean="0"/>
              <a:t>9/27/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55BF1F6-700A-3545-BA57-B9ADB890590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4E0CB8C-0B39-AD4D-A521-959C6E25207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147C02-A659-5E4A-90C1-E3CE6C1002A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9959000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037C052B-6C91-264E-8182-4206886E194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A21CB93-51D2-5B46-8E1E-37CF0BB7CB9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F752F96-2454-5B41-8485-164B359A0453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E55DD28-DE96-C24B-990D-383E662EF2E0}" type="datetimeFigureOut">
              <a:rPr lang="en-US" smtClean="0"/>
              <a:t>9/27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6C7D741-8F20-2542-BC92-4FC71E29FA30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15E3297-BB0A-9A4B-AC74-8A24906F4E49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F147C02-A659-5E4A-90C1-E3CE6C1002A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8938399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sv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FBD09C60-79D4-F14D-9665-B3B690658487}"/>
              </a:ext>
            </a:extLst>
          </p:cNvPr>
          <p:cNvSpPr txBox="1"/>
          <p:nvPr/>
        </p:nvSpPr>
        <p:spPr>
          <a:xfrm>
            <a:off x="11040403" y="6473502"/>
            <a:ext cx="1151597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/>
              <a:t>Figure S5</a:t>
            </a:r>
          </a:p>
        </p:txBody>
      </p:sp>
      <p:pic>
        <p:nvPicPr>
          <p:cNvPr id="7" name="Graphic 6">
            <a:extLst>
              <a:ext uri="{FF2B5EF4-FFF2-40B4-BE49-F238E27FC236}">
                <a16:creationId xmlns:a16="http://schemas.microsoft.com/office/drawing/2014/main" id="{62D4F99F-66D2-284B-9880-45F59C5CD373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96DAC541-7B7A-43D3-8B79-37D633B846F1}">
                <asvg:svgBlip xmlns:asvg="http://schemas.microsoft.com/office/drawing/2016/SVG/main" r:embed="rId3"/>
              </a:ext>
            </a:extLst>
          </a:blip>
          <a:srcRect l="1964" t="12121" b="18706"/>
          <a:stretch/>
        </p:blipFill>
        <p:spPr>
          <a:xfrm>
            <a:off x="175445" y="539495"/>
            <a:ext cx="8511901" cy="5779009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430BFC04-51EC-2B41-BFA7-C08E9529EDA7}"/>
              </a:ext>
            </a:extLst>
          </p:cNvPr>
          <p:cNvSpPr txBox="1"/>
          <p:nvPr/>
        </p:nvSpPr>
        <p:spPr>
          <a:xfrm>
            <a:off x="1889760" y="6252260"/>
            <a:ext cx="77457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CB – 1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D5B0C5AB-8CAB-EF4E-8AF8-87B676451768}"/>
              </a:ext>
            </a:extLst>
          </p:cNvPr>
          <p:cNvSpPr txBox="1"/>
          <p:nvPr/>
        </p:nvSpPr>
        <p:spPr>
          <a:xfrm>
            <a:off x="6096000" y="175734"/>
            <a:ext cx="7713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CB – 4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DBE35C3E-573D-B840-A5CA-51BDF518B5D7}"/>
              </a:ext>
            </a:extLst>
          </p:cNvPr>
          <p:cNvSpPr txBox="1"/>
          <p:nvPr/>
        </p:nvSpPr>
        <p:spPr>
          <a:xfrm>
            <a:off x="1350189" y="903469"/>
            <a:ext cx="107914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CB-O</a:t>
            </a:r>
            <a:r>
              <a:rPr lang="en-US" b="1" baseline="-25000" dirty="0"/>
              <a:t>3</a:t>
            </a:r>
            <a:r>
              <a:rPr lang="en-US" b="1" dirty="0"/>
              <a:t> – 4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4DC82647-5049-0843-BF46-B9A4071B6F82}"/>
              </a:ext>
            </a:extLst>
          </p:cNvPr>
          <p:cNvSpPr txBox="1"/>
          <p:nvPr/>
        </p:nvSpPr>
        <p:spPr>
          <a:xfrm>
            <a:off x="3246424" y="685200"/>
            <a:ext cx="107914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CB-O</a:t>
            </a:r>
            <a:r>
              <a:rPr lang="en-US" b="1" baseline="-25000" dirty="0"/>
              <a:t>3</a:t>
            </a:r>
            <a:r>
              <a:rPr lang="en-US" b="1" dirty="0"/>
              <a:t> – 1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D1D66D99-FD25-A94E-BC1A-7C3DC07D8127}"/>
              </a:ext>
            </a:extLst>
          </p:cNvPr>
          <p:cNvSpPr txBox="1"/>
          <p:nvPr/>
        </p:nvSpPr>
        <p:spPr>
          <a:xfrm>
            <a:off x="2867955" y="1418293"/>
            <a:ext cx="75693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O</a:t>
            </a:r>
            <a:r>
              <a:rPr lang="en-US" b="1" baseline="-25000" dirty="0"/>
              <a:t>3</a:t>
            </a:r>
            <a:r>
              <a:rPr lang="en-US" b="1" dirty="0"/>
              <a:t> – 1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21D0FA0C-4416-0442-A2A9-E8A2BC6D58BE}"/>
              </a:ext>
            </a:extLst>
          </p:cNvPr>
          <p:cNvSpPr txBox="1"/>
          <p:nvPr/>
        </p:nvSpPr>
        <p:spPr>
          <a:xfrm>
            <a:off x="175445" y="2155909"/>
            <a:ext cx="75693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O</a:t>
            </a:r>
            <a:r>
              <a:rPr lang="en-US" b="1" baseline="-25000" dirty="0"/>
              <a:t>3</a:t>
            </a:r>
            <a:r>
              <a:rPr lang="en-US" b="1" dirty="0"/>
              <a:t> – 4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2BF74AEB-93C2-9649-A696-622A4343E763}"/>
              </a:ext>
            </a:extLst>
          </p:cNvPr>
          <p:cNvSpPr txBox="1"/>
          <p:nvPr/>
        </p:nvSpPr>
        <p:spPr>
          <a:xfrm>
            <a:off x="192369" y="285090"/>
            <a:ext cx="37061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DDBE9CC9-C52B-174C-8DFB-43F18F07481D}"/>
              </a:ext>
            </a:extLst>
          </p:cNvPr>
          <p:cNvSpPr txBox="1"/>
          <p:nvPr/>
        </p:nvSpPr>
        <p:spPr>
          <a:xfrm>
            <a:off x="8802031" y="1955854"/>
            <a:ext cx="37061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graphicFrame>
        <p:nvGraphicFramePr>
          <p:cNvPr id="16" name="Table 15">
            <a:extLst>
              <a:ext uri="{FF2B5EF4-FFF2-40B4-BE49-F238E27FC236}">
                <a16:creationId xmlns:a16="http://schemas.microsoft.com/office/drawing/2014/main" id="{DA65F934-CC60-DF42-9C48-1DAD707DB3A0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679112871"/>
              </p:ext>
            </p:extLst>
          </p:nvPr>
        </p:nvGraphicFramePr>
        <p:xfrm>
          <a:off x="8987338" y="2456851"/>
          <a:ext cx="3029216" cy="2060575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778454">
                  <a:extLst>
                    <a:ext uri="{9D8B030D-6E8A-4147-A177-3AD203B41FA5}">
                      <a16:colId xmlns:a16="http://schemas.microsoft.com/office/drawing/2014/main" val="2164773493"/>
                    </a:ext>
                  </a:extLst>
                </a:gridCol>
                <a:gridCol w="907534">
                  <a:extLst>
                    <a:ext uri="{9D8B030D-6E8A-4147-A177-3AD203B41FA5}">
                      <a16:colId xmlns:a16="http://schemas.microsoft.com/office/drawing/2014/main" val="1933478024"/>
                    </a:ext>
                  </a:extLst>
                </a:gridCol>
                <a:gridCol w="665234">
                  <a:extLst>
                    <a:ext uri="{9D8B030D-6E8A-4147-A177-3AD203B41FA5}">
                      <a16:colId xmlns:a16="http://schemas.microsoft.com/office/drawing/2014/main" val="2117229396"/>
                    </a:ext>
                  </a:extLst>
                </a:gridCol>
                <a:gridCol w="677994">
                  <a:extLst>
                    <a:ext uri="{9D8B030D-6E8A-4147-A177-3AD203B41FA5}">
                      <a16:colId xmlns:a16="http://schemas.microsoft.com/office/drawing/2014/main" val="2091428818"/>
                    </a:ext>
                  </a:extLst>
                </a:gridCol>
              </a:tblGrid>
              <a:tr h="2032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 dirty="0">
                          <a:effectLst/>
                          <a:latin typeface="+mn-lt"/>
                        </a:rPr>
                        <a:t>ID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4C7C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 dirty="0">
                          <a:effectLst/>
                          <a:latin typeface="+mn-lt"/>
                        </a:rPr>
                        <a:t>Term Description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4C7C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 dirty="0">
                          <a:effectLst/>
                          <a:latin typeface="+mn-lt"/>
                        </a:rPr>
                        <a:t>Up Regulated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4C7C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 dirty="0">
                          <a:effectLst/>
                          <a:latin typeface="+mn-lt"/>
                        </a:rPr>
                        <a:t>Down Regulated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4C7C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095732779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  <a:latin typeface="+mn-lt"/>
                        </a:rPr>
                        <a:t>mmu04110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4C7C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  <a:latin typeface="+mn-lt"/>
                        </a:rPr>
                        <a:t>Cell cycle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  <a:latin typeface="+mn-lt"/>
                        </a:rPr>
                        <a:t>Rb1, Rbl2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  <a:latin typeface="+mn-lt"/>
                        </a:rPr>
                        <a:t>Ccnd3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147090132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  <a:latin typeface="+mn-lt"/>
                        </a:rPr>
                        <a:t>mmu04213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4C7C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  <a:latin typeface="+mn-lt"/>
                        </a:rPr>
                        <a:t>Longevity regulating pathway - multiple species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  <a:latin typeface="+mn-lt"/>
                        </a:rPr>
                        <a:t>Akt3 Prkaa1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dirty="0"/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489055103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  <a:latin typeface="+mn-lt"/>
                        </a:rPr>
                        <a:t>mmu03040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4C7C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  <a:latin typeface="+mn-lt"/>
                        </a:rPr>
                        <a:t>Spliceosome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 err="1">
                          <a:effectLst/>
                          <a:latin typeface="+mn-lt"/>
                        </a:rPr>
                        <a:t>Snrpb</a:t>
                      </a:r>
                      <a:r>
                        <a:rPr lang="en-US" sz="1200" u="none" strike="noStrike" dirty="0">
                          <a:effectLst/>
                          <a:latin typeface="+mn-lt"/>
                        </a:rPr>
                        <a:t> U2af2 Srsf3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042546564"/>
                  </a:ext>
                </a:extLst>
              </a:tr>
            </a:tbl>
          </a:graphicData>
        </a:graphic>
      </p:graphicFrame>
      <p:sp>
        <p:nvSpPr>
          <p:cNvPr id="17" name="TextBox 16">
            <a:extLst>
              <a:ext uri="{FF2B5EF4-FFF2-40B4-BE49-F238E27FC236}">
                <a16:creationId xmlns:a16="http://schemas.microsoft.com/office/drawing/2014/main" id="{FA90A1D8-A63A-2C4E-AB4D-813653853DC1}"/>
              </a:ext>
            </a:extLst>
          </p:cNvPr>
          <p:cNvSpPr txBox="1"/>
          <p:nvPr/>
        </p:nvSpPr>
        <p:spPr>
          <a:xfrm>
            <a:off x="4817674" y="3428626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*</a:t>
            </a:r>
          </a:p>
        </p:txBody>
      </p:sp>
    </p:spTree>
    <p:extLst>
      <p:ext uri="{BB962C8B-B14F-4D97-AF65-F5344CB8AC3E}">
        <p14:creationId xmlns:p14="http://schemas.microsoft.com/office/powerpoint/2010/main" val="279489601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0</TotalTime>
  <Words>51</Words>
  <Application>Microsoft Macintosh PowerPoint</Application>
  <PresentationFormat>Widescreen</PresentationFormat>
  <Paragraphs>2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Quincy Hathaway</dc:creator>
  <cp:lastModifiedBy>Quincy Hathaway</cp:lastModifiedBy>
  <cp:revision>10</cp:revision>
  <dcterms:created xsi:type="dcterms:W3CDTF">2021-09-27T18:19:07Z</dcterms:created>
  <dcterms:modified xsi:type="dcterms:W3CDTF">2021-09-27T21:13:15Z</dcterms:modified>
</cp:coreProperties>
</file>